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1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72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42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32CD2E-38D9-4DB4-9F21-079DB1427F1E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CD969E-FAE7-417E-8774-4A065C92952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964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81175C-0F55-5A4F-A708-8BE68B8D5B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F11221-F898-EF3E-99E8-6431C83A23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FC1C0A-2EA1-E1EE-D30F-4B5AB2E96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CF7802-1B2F-F0C1-3099-8E4B6C542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8477C8-4918-6FED-3F85-203409E3C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348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88670E-317A-0152-4BB6-1ED47D74A0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5314E9-1BCF-DD76-38BD-FED898DD31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26E314-C98B-E7B0-3AA3-C9CBA0512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B7D4E4-7D77-540F-CEB0-6D204B2B1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75DB7A-E71D-8418-8E09-2B34E6C7E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546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CEE38B-E128-44AC-4C9E-C528D4DDA4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6D3B46-C884-8805-9D87-E5E33729F6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779EDA-1BE2-D496-ABCB-FB11BDE059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D96753-4150-D7BE-B65A-7B2CD78EE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5B9E80-60E1-068E-FE70-ED1A3A7BF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319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381EBB-DD43-C916-14B9-FABA64DC1A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24A38B-D011-3B21-D114-516D4F86B6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C89DC6-5296-79ED-953F-BFCEC2442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C1BFD9-AE66-5E09-8080-C17054675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662F9C-57DA-B3F4-45EE-A5AA0C3F6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56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7541BF-68D8-1355-AB10-39B434D19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647D12-8307-6337-8EC2-D4116BD786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FBAC38-D4D1-8A25-CE10-6423E98ED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E3FE6E-6E64-85BE-7908-AAFA1D2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0D4CDB-0A5A-40A6-078F-939021A2C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305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402DB2-B540-498C-F399-76440CDB4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7F68C5-5E82-8374-4CE2-2E48C9C23A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03DD40-700D-7F5B-8660-FF94226063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FB0F9A-D0F1-5E37-D521-5B411D1F4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6D7C69-1174-8901-B496-B94C62E0D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62EEA1-AF5E-0065-7ED4-82A080D3B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544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5DD90-A674-47C9-5CEE-28CE6F50A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66008A-C44F-64B5-EE3E-CDA50E9265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DC66F0-C43F-39B8-1B96-8BA1D0C843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1487591-239D-E59D-B63F-9FFC24146D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CC7A23-5EF8-4F32-06C3-8C101D9E20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63DACC-ADC7-CF1A-BA51-062F9520C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1E1579-51B2-95A0-A422-C92227A05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F3C71C8-1C04-3BD1-5166-2D770D7D3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875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707CD2-602F-925B-3191-43E958989C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D6CEF4-C26C-BA49-09A5-D137779F7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91277D-5FD6-91A1-0B0B-371266FCF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AB3778-3C3A-D590-9F88-7DEA8F67F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057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40E37D0-B109-A8FE-FBA6-DAFFEEA80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690895-5745-4498-9445-809D96D41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46BA8DC-56F0-F650-221B-AB3734856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519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2B4808-BF16-3E79-174B-FAEC0E989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264D07-9D88-FEAF-BD2C-32EABF04D9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02F7FC-A0B2-47FA-D43E-E009BD3B29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0C0750-186B-F66C-1DB1-244054F3D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2D1A6D-E5E3-F9E8-B340-557369D28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BCD80E-0117-EFD3-26BE-218902370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870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AD745-5689-2895-F343-AFE603F5E3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64972A3-50DF-E830-BA62-37A8DA114E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DA9BC4-8EE5-CEBA-0FF7-D56822FE99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8DE387-A28B-D59E-C103-6E1EB3D91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45375F-CA0B-B464-2960-4B0B20D7E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6B099C-BA6B-C892-92E3-DCF923FD0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74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BE0E58-22AB-037F-7367-E5DC537387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13495B-9F19-2CD6-257D-3343E5539B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DC78C0-3EC1-37D2-AB1C-70CB88FB4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A6517-853F-410C-ADFB-8BEC73587766}" type="datetimeFigureOut">
              <a:rPr lang="en-US" smtClean="0"/>
              <a:t>6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3AF2A1-8D15-BF94-A75E-A8C4D2EAC3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2B1C5-390F-093C-946C-FE62729C63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B6FB5-B6BA-4818-AFB2-00875DA9E3E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217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magine 8">
            <a:extLst>
              <a:ext uri="{FF2B5EF4-FFF2-40B4-BE49-F238E27FC236}">
                <a16:creationId xmlns:a16="http://schemas.microsoft.com/office/drawing/2014/main" id="{15D58C01-32A1-1C00-805F-3BFBEF4FA35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29228"/>
          <a:stretch/>
        </p:blipFill>
        <p:spPr>
          <a:xfrm>
            <a:off x="1042158" y="479894"/>
            <a:ext cx="7413473" cy="628231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E788329-F071-6795-D4FB-7213E73FFD8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73240"/>
          <a:stretch/>
        </p:blipFill>
        <p:spPr>
          <a:xfrm>
            <a:off x="4431592" y="4158693"/>
            <a:ext cx="1017144" cy="1314633"/>
          </a:xfrm>
          <a:prstGeom prst="rect">
            <a:avLst/>
          </a:prstGeom>
        </p:spPr>
      </p:pic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17A2FBD2-90A0-F72C-9DA0-60F08381FA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8427950"/>
              </p:ext>
            </p:extLst>
          </p:nvPr>
        </p:nvGraphicFramePr>
        <p:xfrm>
          <a:off x="5448734" y="4245374"/>
          <a:ext cx="6304901" cy="12074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277486">
                  <a:extLst>
                    <a:ext uri="{9D8B030D-6E8A-4147-A177-3AD203B41FA5}">
                      <a16:colId xmlns:a16="http://schemas.microsoft.com/office/drawing/2014/main" val="2952711423"/>
                    </a:ext>
                  </a:extLst>
                </a:gridCol>
                <a:gridCol w="1027415">
                  <a:extLst>
                    <a:ext uri="{9D8B030D-6E8A-4147-A177-3AD203B41FA5}">
                      <a16:colId xmlns:a16="http://schemas.microsoft.com/office/drawing/2014/main" val="4061430863"/>
                    </a:ext>
                  </a:extLst>
                </a:gridCol>
              </a:tblGrid>
              <a:tr h="402468">
                <a:tc>
                  <a:txBody>
                    <a:bodyPr/>
                    <a:lstStyle/>
                    <a:p>
                      <a:r>
                        <a:rPr lang="it-IT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MCA to LAD </a:t>
                      </a:r>
                      <a:r>
                        <a:rPr lang="it-IT" sz="14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ly</a:t>
                      </a:r>
                      <a:r>
                        <a:rPr lang="it-IT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FR </a:t>
                      </a:r>
                      <a:r>
                        <a:rPr lang="it-IT" sz="14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essment</a:t>
                      </a:r>
                      <a:r>
                        <a:rPr lang="it-IT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– AUC = 0.90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9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2515362"/>
                  </a:ext>
                </a:extLst>
              </a:tr>
              <a:tr h="402468"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MCA to both LAD and </a:t>
                      </a:r>
                      <a:r>
                        <a:rPr lang="en-US" sz="1400" b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Cx </a:t>
                      </a:r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FR assessment </a:t>
                      </a:r>
                      <a:r>
                        <a:rPr lang="it-IT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– AUC = 0.98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3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6595170"/>
                  </a:ext>
                </a:extLst>
              </a:tr>
              <a:tr h="402468"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3609817"/>
                  </a:ext>
                </a:extLst>
              </a:tr>
            </a:tbl>
          </a:graphicData>
        </a:graphic>
      </p:graphicFrame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5B280D4-E6E5-3F74-F121-82DA92670109}"/>
              </a:ext>
            </a:extLst>
          </p:cNvPr>
          <p:cNvSpPr txBox="1"/>
          <p:nvPr/>
        </p:nvSpPr>
        <p:spPr>
          <a:xfrm>
            <a:off x="6264667" y="3244334"/>
            <a:ext cx="17697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1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alue = 0.18</a:t>
            </a:r>
            <a:endParaRPr lang="it-IT" dirty="0">
              <a:solidFill>
                <a:srgbClr val="FF0000"/>
              </a:solidFill>
            </a:endParaRPr>
          </a:p>
        </p:txBody>
      </p:sp>
      <p:sp>
        <p:nvSpPr>
          <p:cNvPr id="6" name="CasellaDiTesto 2"/>
          <p:cNvSpPr txBox="1"/>
          <p:nvPr/>
        </p:nvSpPr>
        <p:spPr>
          <a:xfrm>
            <a:off x="0" y="21740"/>
            <a:ext cx="2731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b="1" dirty="0" err="1" smtClean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Supplementary</a:t>
            </a:r>
            <a:r>
              <a:rPr lang="it-IT" b="1" dirty="0" smtClean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</a:t>
            </a:r>
            <a:r>
              <a:rPr lang="it-IT" b="1" smtClean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</a:t>
            </a:r>
            <a:r>
              <a:rPr lang="it-IT" b="1" smtClean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4</a:t>
            </a:r>
            <a:endParaRPr lang="it-IT" b="1" dirty="0"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0966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eonardo Grisafi</dc:creator>
  <cp:lastModifiedBy>Grisafi Leonardo-Dir med (&lt; 5)</cp:lastModifiedBy>
  <cp:revision>119</cp:revision>
  <dcterms:created xsi:type="dcterms:W3CDTF">2024-12-02T08:49:01Z</dcterms:created>
  <dcterms:modified xsi:type="dcterms:W3CDTF">2025-06-05T09:02:48Z</dcterms:modified>
</cp:coreProperties>
</file>